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7"/>
  </p:notesMasterIdLst>
  <p:sldIdLst>
    <p:sldId id="256" r:id="rId2"/>
    <p:sldId id="261" r:id="rId3"/>
    <p:sldId id="258" r:id="rId4"/>
    <p:sldId id="259" r:id="rId5"/>
    <p:sldId id="260" r:id="rId6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2183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2" roundtripDataSignature="AMtx7mhddnAnpOkSaMgGKrD5LEeMJa2HN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BBACBED7-DB33-436E-BFBC-FB6EA246848B}">
  <a:tblStyle styleId="{BBACBED7-DB33-436E-BFBC-FB6EA246848B}" styleName="Table_0">
    <a:wholeTbl>
      <a:tcTxStyle b="off" i="off"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 b="off" i="off"/>
      <a:tcStyle>
        <a:tcBdr/>
      </a:tcStyle>
    </a:band1H>
    <a:band2H>
      <a:tcTxStyle b="off" i="off"/>
      <a:tcStyle>
        <a:tcBdr/>
      </a:tcStyle>
    </a:band2H>
    <a:band1V>
      <a:tcTxStyle b="off" i="off"/>
      <a:tcStyle>
        <a:tcBdr/>
      </a:tcStyle>
    </a:band1V>
    <a:band2V>
      <a:tcTxStyle b="off" i="off"/>
      <a:tcStyle>
        <a:tcBdr/>
      </a:tcStyle>
    </a:band2V>
    <a:lastCol>
      <a:tcTxStyle b="off" i="off"/>
      <a:tcStyle>
        <a:tcBdr/>
      </a:tcStyle>
    </a:lastCol>
    <a:firstCol>
      <a:tcTxStyle b="off" i="off"/>
      <a:tcStyle>
        <a:tcBdr/>
      </a:tcStyle>
    </a:firstCol>
    <a:lastRow>
      <a:tcTxStyle b="off" i="off"/>
      <a:tcStyle>
        <a:tcBdr/>
      </a:tcStyle>
    </a:lastRow>
    <a:seCell>
      <a:tcTxStyle b="off" i="off"/>
      <a:tcStyle>
        <a:tcBdr/>
      </a:tcStyle>
    </a:seCell>
    <a:swCell>
      <a:tcTxStyle b="off" i="off"/>
      <a:tcStyle>
        <a:tcBdr/>
      </a:tcStyle>
    </a:swCell>
    <a:firstRow>
      <a:tcTxStyle b="off" i="off"/>
      <a:tcStyle>
        <a:tcBdr/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512" y="52"/>
      </p:cViewPr>
      <p:guideLst>
        <p:guide orient="horz" pos="2183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customschemas.google.com/relationships/presentationmetadata" Target="metadata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4" Type="http://schemas.openxmlformats.org/officeDocument/2006/relationships/slide" Target="slides/slide3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s-CL"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3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74" name="Google Shape;74;p33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Google Shape;88;p9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89" name="Google Shape;89;p9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Google Shape;117;p34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18" name="Google Shape;118;p34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119" name="Google Shape;119;p34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"/>
              <a:buNone/>
            </a:pPr>
            <a:fld id="{00000000-1234-1234-1234-123412341234}" type="slidenum">
              <a:rPr lang="es-CL"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4</a:t>
            </a:fld>
            <a:endParaRPr sz="12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Google Shape;136;p1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137" name="Google Shape;137;p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En blanco" type="blank">
  <p:cSld name="BLANK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2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2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2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CL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Encabezado de sección" type="secHead">
  <p:cSld name="SECTION_HEADER">
    <p:spTree>
      <p:nvGrpSpPr>
        <p:cNvPr id="1" name="Shape 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Google Shape;20;p25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25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2" name="Google Shape;22;p2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2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2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CL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os objetos" type="twoObj">
  <p:cSld name="TWO_OBJECTS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26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26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8" name="Google Shape;28;p26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9" name="Google Shape;29;p2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2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2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CL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ación" type="twoTxTwoObj">
  <p:cSld name="TWO_OBJECTS_WITH_TEX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27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27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35" name="Google Shape;35;p27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27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37" name="Google Shape;37;p27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8" name="Google Shape;38;p2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2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0" name="Google Shape;40;p2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CL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olo el título" type="titleOnly">
  <p:cSld name="TITLE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28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2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2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5" name="Google Shape;45;p2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CL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ido con título" type="objTx">
  <p:cSld name="OBJECT_WITH_CAPTION_TEXT">
    <p:spTree>
      <p:nvGrpSpPr>
        <p:cNvPr id="1" name="Shape 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Google Shape;47;p29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29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49" name="Google Shape;49;p29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0" name="Google Shape;50;p2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2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2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CL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agen con título" type="picTx">
  <p:cSld name="PICTURE_WITH_CAPTION_TEXT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30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30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56" name="Google Shape;56;p30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7" name="Google Shape;57;p3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8" name="Google Shape;58;p3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3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CL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y texto vertical" type="vertTx">
  <p:cSld name="VERTICAL_TEXT">
    <p:spTree>
      <p:nvGrpSpPr>
        <p:cNvPr id="1" name="Shape 6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Google Shape;61;p3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2" name="Google Shape;62;p31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63" name="Google Shape;63;p3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3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5" name="Google Shape;65;p3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CL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vertical y texto" type="vertTitleAndTx">
  <p:cSld name="VERTICAL_TITLE_AND_VERTICAL_TEXT">
    <p:spTree>
      <p:nvGrpSpPr>
        <p:cNvPr id="1" name="Shape 6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Google Shape;67;p32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8" name="Google Shape;68;p32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69" name="Google Shape;69;p3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3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3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CL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21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2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2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2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CL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oleObject" Target="../embeddings/oleObject5.bin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Google Shape;76;p33"/>
          <p:cNvSpPr txBox="1"/>
          <p:nvPr/>
        </p:nvSpPr>
        <p:spPr>
          <a:xfrm>
            <a:off x="3" y="0"/>
            <a:ext cx="6413700" cy="92328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s-CL" sz="18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</a:t>
            </a:r>
            <a:r>
              <a:rPr lang="es-CL" sz="18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Table 1.</a:t>
            </a: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s-CL" sz="18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List</a:t>
            </a:r>
            <a:r>
              <a:rPr lang="es-CL" sz="18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f</a:t>
            </a:r>
            <a:r>
              <a:rPr lang="es-CL" sz="18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primer </a:t>
            </a:r>
            <a:r>
              <a:rPr lang="es-CL" sz="18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used</a:t>
            </a:r>
            <a:r>
              <a:rPr lang="es-CL" sz="18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in PCR</a:t>
            </a: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s-CL" sz="18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nd RT-</a:t>
            </a:r>
            <a:r>
              <a:rPr lang="es-CL" sz="18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qPCR</a:t>
            </a:r>
            <a:r>
              <a:rPr lang="es-CL" sz="18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   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3" name="Google Shape;77;p33">
            <a:extLst>
              <a:ext uri="{FF2B5EF4-FFF2-40B4-BE49-F238E27FC236}">
                <a16:creationId xmlns:a16="http://schemas.microsoft.com/office/drawing/2014/main" id="{6DE20172-683C-B231-C824-AA3D922D23B1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077441458"/>
              </p:ext>
            </p:extLst>
          </p:nvPr>
        </p:nvGraphicFramePr>
        <p:xfrm>
          <a:off x="3333318" y="42773"/>
          <a:ext cx="6160770" cy="6642780"/>
        </p:xfrm>
        <a:graphic>
          <a:graphicData uri="http://schemas.openxmlformats.org/drawingml/2006/table">
            <a:tbl>
              <a:tblPr>
                <a:noFill/>
                <a:tableStyleId>{BBACBED7-DB33-436E-BFBC-FB6EA246848B}</a:tableStyleId>
              </a:tblPr>
              <a:tblGrid>
                <a:gridCol w="63317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4529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09686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8543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Number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Primer Name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Sequence 5' 3'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 dirty="0" err="1"/>
                        <a:t>Accession</a:t>
                      </a:r>
                      <a:r>
                        <a:rPr lang="es-CL" sz="800" u="none" strike="noStrike" cap="none" dirty="0"/>
                        <a:t> </a:t>
                      </a:r>
                      <a:r>
                        <a:rPr lang="es-CL" sz="800" u="none" strike="noStrike" cap="none" dirty="0" err="1"/>
                        <a:t>number</a:t>
                      </a:r>
                      <a:endParaRPr sz="800" u="none" strike="noStrike" cap="none" dirty="0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1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SlLIP1m_F_AscI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 dirty="0"/>
                        <a:t>GGCGCGCCATGAATTCCCGTTTCACATCTCTCGTTT</a:t>
                      </a:r>
                      <a:endParaRPr sz="800" u="none" strike="noStrike" cap="none" dirty="0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Solyc07g054540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2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His6_R_AscI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GGCGCGCCCTAAGCATGATGATGATGATGATGGC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 dirty="0"/>
                        <a:t>-</a:t>
                      </a:r>
                      <a:endParaRPr sz="800" u="none" strike="noStrike" cap="none" dirty="0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3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pPG_F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TAAGTACCATCACATAATTGAGACGAAG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Solyc10g080210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4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His3R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GCATGATGATGATGATGATGGCTG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-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5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qPCR_SlLIP1_F 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GCCATTGCTTCATGGGGATT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 dirty="0"/>
                        <a:t>Solyc07g054540</a:t>
                      </a:r>
                      <a:endParaRPr sz="800" u="none" strike="noStrike" cap="none" dirty="0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6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qPCR_SlLIP1_R 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TACACACCCAGGATCACCTCT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s-CL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7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qPCR_SlLIP1p_F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AGAATGTTGGAATGGTGGTGGAGATG 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Solyc12g099700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8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qPCR_SlLIP1p_R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 dirty="0"/>
                        <a:t>ATAGGGTCAGGAGGAGCAGGATTTC</a:t>
                      </a:r>
                      <a:endParaRPr sz="800" u="none" strike="noStrike" cap="none" dirty="0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s-CL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9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qPCR_SlLIP2_F 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AAGATTGGCGCGATTGGAGT 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 dirty="0"/>
                        <a:t>Solyc02g077460</a:t>
                      </a:r>
                      <a:endParaRPr sz="800" u="none" strike="noStrike" cap="none" dirty="0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10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qPCR_SlLIP2_R 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CTTCAGCGGGAAGCTCTACA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s-CL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11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qPCR_SlLPLA_F 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GCAACACAGATGCTCTCCCT 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Solyc06g065310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12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qPCR_SlLPLA_R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ATGATGAACCCAACGCCCTT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s-CL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13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qPCR_PDHm_F 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GCCGGTCCTTGTAACTCCTC 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 dirty="0"/>
                        <a:t>Solyc11g007720</a:t>
                      </a:r>
                      <a:endParaRPr sz="800" u="none" strike="noStrike" cap="none" dirty="0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14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qPCR_PDHm_R 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CCTGACCAAACTTAATGAAGAAGCA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s-CL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15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qPCR_PDHc_F 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CTTGGGCATGTTTGGTGTGG 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 dirty="0"/>
                        <a:t>Solyc05g009530</a:t>
                      </a:r>
                      <a:endParaRPr sz="800" u="none" strike="noStrike" cap="none" dirty="0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16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qPCR_PDHc_R 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ACTCGGTGATCTGCTGTGAC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s-CL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17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qPCR_kGDH_F 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ATGGTTGTTGGAGGCGTCAT 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Solyc12g005080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18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/>
                        <a:t>qPCR_kGDH_R </a:t>
                      </a:r>
                      <a:endParaRPr sz="800" u="none" strike="noStrike" cap="none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CL" sz="800" u="none" strike="noStrike" cap="none" dirty="0"/>
                        <a:t>AACATCAAGGAGTAGGCGGC</a:t>
                      </a:r>
                      <a:endParaRPr sz="800" u="none" strike="noStrike" cap="none" dirty="0"/>
                    </a:p>
                  </a:txBody>
                  <a:tcPr marL="91425" marR="91425" marT="54000" marB="54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s-CL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200"/>
                        <a:buFont typeface="Arial"/>
                        <a:buNone/>
                      </a:pPr>
                      <a:r>
                        <a:rPr lang="es-CL" sz="800" u="none" strike="noStrike" cap="none" dirty="0"/>
                        <a:t>19</a:t>
                      </a:r>
                      <a:endParaRPr sz="800" u="none" strike="noStrike" cap="none" dirty="0"/>
                    </a:p>
                  </a:txBody>
                  <a:tcPr marL="91425" marR="91425" marT="36000" marB="36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200"/>
                        <a:buFont typeface="Arial"/>
                        <a:buNone/>
                      </a:pPr>
                      <a:r>
                        <a:rPr lang="es-CL" sz="800" u="none" strike="noStrike" cap="none"/>
                        <a:t>qPCR_SlSAMS_F</a:t>
                      </a:r>
                      <a:endParaRPr sz="800" u="none" strike="noStrike" cap="none"/>
                    </a:p>
                  </a:txBody>
                  <a:tcPr marL="91425" marR="91425" marT="36000" marB="36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200"/>
                        <a:buFont typeface="Arial"/>
                        <a:buNone/>
                      </a:pPr>
                      <a:r>
                        <a:rPr lang="es-CL" sz="800" u="none" strike="noStrike" cap="none"/>
                        <a:t>CCGTCTTACAGAAGTCCGCA </a:t>
                      </a:r>
                      <a:endParaRPr sz="800" u="none" strike="noStrike" cap="none"/>
                    </a:p>
                  </a:txBody>
                  <a:tcPr marL="91425" marR="91425" marT="36000" marB="36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200"/>
                        <a:buFont typeface="Arial"/>
                        <a:buNone/>
                      </a:pPr>
                      <a:r>
                        <a:rPr lang="es-CL" sz="800" u="none" strike="noStrike" cap="none"/>
                        <a:t>Solyc01g101060</a:t>
                      </a:r>
                      <a:endParaRPr sz="800" u="none" strike="noStrike" cap="none"/>
                    </a:p>
                  </a:txBody>
                  <a:tcPr marL="91425" marR="91425" marT="36000" marB="36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200"/>
                        <a:buFont typeface="Arial"/>
                        <a:buNone/>
                      </a:pPr>
                      <a:r>
                        <a:rPr lang="es-CL" sz="800" u="none" strike="noStrike" cap="none"/>
                        <a:t>20</a:t>
                      </a:r>
                      <a:endParaRPr sz="800" u="none" strike="noStrike" cap="none"/>
                    </a:p>
                  </a:txBody>
                  <a:tcPr marL="91425" marR="91425" marT="36000" marB="36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200"/>
                        <a:buFont typeface="Arial"/>
                        <a:buNone/>
                      </a:pPr>
                      <a:r>
                        <a:rPr lang="es-CL" sz="800" u="none" strike="noStrike" cap="none"/>
                        <a:t>qPCR_SlSAMS_R</a:t>
                      </a:r>
                      <a:endParaRPr sz="800" u="none" strike="noStrike" cap="none"/>
                    </a:p>
                  </a:txBody>
                  <a:tcPr marL="91425" marR="91425" marT="36000" marB="36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200"/>
                        <a:buFont typeface="Arial"/>
                        <a:buNone/>
                      </a:pPr>
                      <a:r>
                        <a:rPr lang="es-CL" sz="800" u="none" strike="noStrike" cap="none"/>
                        <a:t>AACGGTCTCATCGTGTTGGG</a:t>
                      </a:r>
                      <a:endParaRPr sz="800" u="none" strike="noStrike" cap="none"/>
                    </a:p>
                  </a:txBody>
                  <a:tcPr marL="91425" marR="91425" marT="36000" marB="36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s-CL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s-CL" sz="800" u="none" strike="noStrike" cap="none"/>
                        <a:t>21</a:t>
                      </a:r>
                      <a:endParaRPr sz="800" u="none" strike="noStrike" cap="none"/>
                    </a:p>
                  </a:txBody>
                  <a:tcPr marL="91425" marR="91425" marT="36000" marB="36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s-CL" sz="800" u="none" strike="noStrike" cap="none"/>
                        <a:t>qPCR_ACT_F</a:t>
                      </a:r>
                      <a:endParaRPr sz="800" u="none" strike="noStrike" cap="none"/>
                    </a:p>
                  </a:txBody>
                  <a:tcPr marL="91425" marR="91425" marT="36000" marB="36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s-CL" sz="800" u="none" strike="noStrike" cap="none"/>
                        <a:t>TGTCCCTATTTACGAGGGTTATGC</a:t>
                      </a:r>
                      <a:endParaRPr sz="800" u="none" strike="noStrike" cap="none"/>
                    </a:p>
                  </a:txBody>
                  <a:tcPr marL="91425" marR="91425" marT="36000" marB="36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s-CL" sz="800" u="none" strike="noStrike" cap="none" dirty="0"/>
                        <a:t>Solyc11g005330</a:t>
                      </a:r>
                      <a:endParaRPr sz="800" u="none" strike="noStrike" cap="none" dirty="0"/>
                    </a:p>
                  </a:txBody>
                  <a:tcPr marL="91425" marR="91425" marT="36000" marB="36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s-CL" sz="800" u="none" strike="noStrike" cap="none"/>
                        <a:t>22</a:t>
                      </a:r>
                      <a:endParaRPr sz="800" u="none" strike="noStrike" cap="none"/>
                    </a:p>
                  </a:txBody>
                  <a:tcPr marL="91425" marR="91425" marT="36000" marB="36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s-CL" sz="800" u="none" strike="noStrike" cap="none" dirty="0" err="1"/>
                        <a:t>qPCR_ACT_R</a:t>
                      </a:r>
                      <a:endParaRPr sz="800" u="none" strike="noStrike" cap="none" dirty="0"/>
                    </a:p>
                  </a:txBody>
                  <a:tcPr marL="91425" marR="91425" marT="36000" marB="36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s-CL" sz="800" u="none" strike="noStrike" cap="none" dirty="0"/>
                        <a:t>CAGTTAAATCACGACCAGCAAGAT</a:t>
                      </a:r>
                      <a:endParaRPr sz="800" u="none" strike="noStrike" cap="none" dirty="0"/>
                    </a:p>
                  </a:txBody>
                  <a:tcPr marL="91425" marR="91425" marT="36000" marB="36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s-CL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s-CL" sz="800" u="none" strike="noStrike" cap="none" dirty="0"/>
                        <a:t>23</a:t>
                      </a:r>
                      <a:endParaRPr sz="800" u="none" strike="noStrike" cap="none" dirty="0"/>
                    </a:p>
                  </a:txBody>
                  <a:tcPr marL="91425" marR="91425" marT="36000" marB="36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s-CL" sz="800" u="none" strike="noStrike" cap="none"/>
                        <a:t>Sl_GAPDH_F</a:t>
                      </a:r>
                      <a:endParaRPr sz="800" u="none" strike="noStrike" cap="none"/>
                    </a:p>
                  </a:txBody>
                  <a:tcPr marL="91425" marR="91425" marT="36000" marB="36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s-CL" sz="800" u="none" strike="noStrike" cap="none"/>
                        <a:t>TGTTTAAGTATGATAGTGTACACGGC</a:t>
                      </a:r>
                      <a:endParaRPr sz="800" u="none" strike="noStrike" cap="none"/>
                    </a:p>
                  </a:txBody>
                  <a:tcPr marL="91425" marR="91425" marT="36000" marB="36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s-CL" sz="800" u="none" strike="noStrike" cap="none" dirty="0"/>
                        <a:t>Solyc05g014470</a:t>
                      </a:r>
                      <a:endParaRPr sz="800" u="none" strike="noStrike" cap="none" dirty="0"/>
                    </a:p>
                  </a:txBody>
                  <a:tcPr marL="91425" marR="91425" marT="36000" marB="36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s-CL" sz="800" u="none" strike="noStrike" cap="none"/>
                        <a:t>24</a:t>
                      </a:r>
                      <a:endParaRPr sz="800" u="none" strike="noStrike" cap="none"/>
                    </a:p>
                  </a:txBody>
                  <a:tcPr marL="91425" marR="91425" marT="36000" marB="36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s-CL" sz="800" u="none" strike="noStrike" cap="none"/>
                        <a:t>Sl_GAPDH_R</a:t>
                      </a:r>
                      <a:endParaRPr sz="800" u="none" strike="noStrike" cap="none"/>
                    </a:p>
                  </a:txBody>
                  <a:tcPr marL="91425" marR="91425" marT="36000" marB="36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s-CL" sz="800" u="none" strike="noStrike" cap="none" dirty="0"/>
                        <a:t>GCTCAAAGCAATTCCAGCCTTG</a:t>
                      </a:r>
                      <a:endParaRPr sz="800" u="none" strike="noStrike" cap="none" dirty="0"/>
                    </a:p>
                  </a:txBody>
                  <a:tcPr marL="91425" marR="91425" marT="36000" marB="36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s-CL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s-CL" sz="800" u="none" strike="noStrike" cap="none" dirty="0"/>
                        <a:t>25</a:t>
                      </a:r>
                      <a:endParaRPr sz="800" u="none" strike="noStrike" cap="none" dirty="0"/>
                    </a:p>
                  </a:txBody>
                  <a:tcPr marL="91425" marR="91425" marT="36000" marB="36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s-CL" sz="800" u="none" strike="noStrike" cap="none" dirty="0"/>
                        <a:t>qPCR_SlPG14_F</a:t>
                      </a:r>
                      <a:endParaRPr sz="800" u="none" strike="noStrike" cap="none" dirty="0"/>
                    </a:p>
                  </a:txBody>
                  <a:tcPr marL="91425" marR="91425" marT="36000" marB="36000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s-CL" sz="800" u="none" strike="noStrike" cap="none" dirty="0"/>
                        <a:t>TCAAAATGTGCAGGCCACAAA</a:t>
                      </a:r>
                      <a:endParaRPr sz="800" u="none" strike="noStrike" cap="none" dirty="0"/>
                    </a:p>
                  </a:txBody>
                  <a:tcPr marL="91425" marR="91425" marT="36000" marB="36000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s-CL" sz="800" u="none" strike="noStrike" cap="none" dirty="0"/>
                        <a:t>Solyc10g080210</a:t>
                      </a:r>
                      <a:endParaRPr sz="800" u="none" strike="noStrike" cap="none" dirty="0"/>
                    </a:p>
                  </a:txBody>
                  <a:tcPr marL="91425" marR="91425" marT="36000" marB="36000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0247930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s-CL" sz="800" u="none" strike="noStrike" cap="none" dirty="0"/>
                        <a:t>26</a:t>
                      </a:r>
                      <a:endParaRPr sz="800" u="none" strike="noStrike" cap="none" dirty="0"/>
                    </a:p>
                  </a:txBody>
                  <a:tcPr marL="91425" marR="91425" marT="36000" marB="36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s-CL" sz="800" u="none" strike="noStrike" cap="none" dirty="0"/>
                        <a:t>qPCR_SlPG14_R</a:t>
                      </a:r>
                      <a:endParaRPr sz="800" u="none" strike="noStrike" cap="none" dirty="0"/>
                    </a:p>
                  </a:txBody>
                  <a:tcPr marL="91425" marR="91425" marT="36000" marB="36000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s-CL" sz="800" u="none" strike="noStrike" cap="none" dirty="0"/>
                        <a:t>GCTTGTCCAGATCCTCCCTG</a:t>
                      </a:r>
                      <a:endParaRPr sz="800" u="none" strike="noStrike" cap="none" dirty="0"/>
                    </a:p>
                  </a:txBody>
                  <a:tcPr marL="91425" marR="91425" marT="36000" marB="36000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endParaRPr sz="800" u="none" strike="noStrike" cap="none" dirty="0"/>
                    </a:p>
                  </a:txBody>
                  <a:tcPr marL="91425" marR="91425" marT="54000" marB="54000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1159347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s-CL" sz="800" u="none" strike="noStrike" cap="none" dirty="0"/>
                        <a:t>27</a:t>
                      </a:r>
                      <a:endParaRPr sz="800" u="none" strike="noStrike" cap="none" dirty="0"/>
                    </a:p>
                  </a:txBody>
                  <a:tcPr marL="91425" marR="91425" marT="36000" marB="36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s-CL" sz="800" u="none" strike="noStrike" cap="none" dirty="0"/>
                        <a:t>qPCR_SlNAP2_F</a:t>
                      </a:r>
                      <a:endParaRPr sz="800" u="none" strike="noStrike" cap="none" dirty="0"/>
                    </a:p>
                  </a:txBody>
                  <a:tcPr marL="91425" marR="91425" marT="36000" marB="36000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s-CL" sz="800" u="none" strike="noStrike" cap="none" dirty="0"/>
                        <a:t>GAGGTTGGATGATTGGGTACTTT</a:t>
                      </a:r>
                      <a:endParaRPr sz="800" u="none" strike="noStrike" cap="none" dirty="0"/>
                    </a:p>
                  </a:txBody>
                  <a:tcPr marL="91425" marR="91425" marT="36000" marB="36000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s-CL" sz="800" u="none" strike="noStrike" cap="none" dirty="0"/>
                        <a:t>Solyc04g005610</a:t>
                      </a:r>
                      <a:endParaRPr sz="800" u="none" strike="noStrike" cap="none" dirty="0"/>
                    </a:p>
                  </a:txBody>
                  <a:tcPr marL="91425" marR="91425" marT="36000" marB="36000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688179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marL="0" marR="0" lvl="0" indent="0" algn="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s-CL" sz="800" u="none" strike="noStrike" cap="none" dirty="0"/>
                        <a:t>28</a:t>
                      </a:r>
                      <a:endParaRPr sz="800" u="none" strike="noStrike" cap="none" dirty="0"/>
                    </a:p>
                  </a:txBody>
                  <a:tcPr marL="91425" marR="91425" marT="36000" marB="36000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s-CL" sz="800" u="none" strike="noStrike" cap="none" dirty="0"/>
                        <a:t>qPCR_SlNAP2_R</a:t>
                      </a:r>
                      <a:endParaRPr sz="800" u="none" strike="noStrike" cap="none" dirty="0"/>
                    </a:p>
                  </a:txBody>
                  <a:tcPr marL="91425" marR="91425" marT="36000" marB="36000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s-CL" sz="800" u="none" strike="noStrike" cap="none" dirty="0"/>
                        <a:t>TTTGAGGTTCTTGTGTGTCTTCTTC</a:t>
                      </a:r>
                      <a:endParaRPr sz="800" u="none" strike="noStrike" cap="none" dirty="0"/>
                    </a:p>
                  </a:txBody>
                  <a:tcPr marL="91425" marR="91425" marT="36000" marB="36000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endParaRPr sz="800" u="none" strike="noStrike" cap="none" dirty="0"/>
                    </a:p>
                  </a:txBody>
                  <a:tcPr marL="91425" marR="91425" marT="54000" marB="54000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121774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to 5">
            <a:extLst>
              <a:ext uri="{FF2B5EF4-FFF2-40B4-BE49-F238E27FC236}">
                <a16:creationId xmlns:a16="http://schemas.microsoft.com/office/drawing/2014/main" id="{072428A6-7E32-D619-CDB9-366B9216C0E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72978721"/>
              </p:ext>
            </p:extLst>
          </p:nvPr>
        </p:nvGraphicFramePr>
        <p:xfrm>
          <a:off x="8466936" y="646175"/>
          <a:ext cx="3952056" cy="25808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2" imgW="4502057" imgH="2939577" progId="Prism6.Document">
                  <p:embed/>
                </p:oleObj>
              </mc:Choice>
              <mc:Fallback>
                <p:oleObj name="Prism 6" r:id="rId2" imgW="4502057" imgH="2939577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466936" y="646175"/>
                        <a:ext cx="3952056" cy="25808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Google Shape;82;p8">
            <a:extLst>
              <a:ext uri="{FF2B5EF4-FFF2-40B4-BE49-F238E27FC236}">
                <a16:creationId xmlns:a16="http://schemas.microsoft.com/office/drawing/2014/main" id="{F6D4A092-BE78-5243-5EDB-0410A2FAE197}"/>
              </a:ext>
            </a:extLst>
          </p:cNvPr>
          <p:cNvSpPr txBox="1"/>
          <p:nvPr/>
        </p:nvSpPr>
        <p:spPr>
          <a:xfrm>
            <a:off x="279441" y="5127792"/>
            <a:ext cx="11310257" cy="12002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Supplementary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Figure 1.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Transcript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levels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in WT and T2 PG-SlLIP1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fruits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during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development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. </a:t>
            </a:r>
            <a:r>
              <a:rPr lang="es-CL" sz="1800" b="1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(A)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qRT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-PCR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analysis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of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1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Polygalacturonase</a:t>
            </a:r>
            <a:r>
              <a:rPr lang="es-CL" sz="1800" b="0" i="1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14 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(</a:t>
            </a:r>
            <a:r>
              <a:rPr lang="es-CL" sz="1800" b="0" i="1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SlPG14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)</a:t>
            </a:r>
            <a:r>
              <a:rPr lang="es-CL" sz="1800" b="0" i="1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. </a:t>
            </a:r>
            <a:r>
              <a:rPr lang="es-CL" sz="1800" b="1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(B)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.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qRT</a:t>
            </a:r>
            <a:r>
              <a:rPr lang="es-CL" sz="1800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-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PCR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analysis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of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1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NAC </a:t>
            </a:r>
            <a:r>
              <a:rPr lang="es-CL" sz="1800" b="0" i="1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domain-containing</a:t>
            </a:r>
            <a:r>
              <a:rPr lang="es-CL" sz="1800" b="0" i="1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1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protein</a:t>
            </a:r>
            <a:r>
              <a:rPr lang="es-CL" sz="1800" b="0" i="1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2 </a:t>
            </a:r>
            <a:r>
              <a:rPr lang="es-CL" sz="1800" b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(</a:t>
            </a:r>
            <a:r>
              <a:rPr lang="es-CL" sz="1800" b="0" i="1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NAP2</a:t>
            </a:r>
            <a:r>
              <a:rPr lang="es-CL" sz="1800" b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)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. </a:t>
            </a:r>
            <a:r>
              <a:rPr lang="es-CL" sz="1800" b="1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(C)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qRT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-PCR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of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total </a:t>
            </a:r>
            <a:r>
              <a:rPr lang="es-CL" sz="1800" b="0" i="1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SlLIP1.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In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all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cases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the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analysis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was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performed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on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three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different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fruits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,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each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with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two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technical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replicates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(n=6 ± SD),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normalized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against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1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Actin7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and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calibrated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to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green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stage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WT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levels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.  </a:t>
            </a:r>
            <a:endParaRPr sz="1400" b="0" i="0" u="none" strike="noStrike" cap="none" dirty="0">
              <a:solidFill>
                <a:schemeClr val="tx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" name="Google Shape;83;p8">
            <a:extLst>
              <a:ext uri="{FF2B5EF4-FFF2-40B4-BE49-F238E27FC236}">
                <a16:creationId xmlns:a16="http://schemas.microsoft.com/office/drawing/2014/main" id="{B5642F0B-EF43-4CDE-B258-BBC7D0FEF831}"/>
              </a:ext>
            </a:extLst>
          </p:cNvPr>
          <p:cNvSpPr txBox="1"/>
          <p:nvPr/>
        </p:nvSpPr>
        <p:spPr>
          <a:xfrm>
            <a:off x="185057" y="209550"/>
            <a:ext cx="293914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s-CL" sz="18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" name="Google Shape;83;p8">
            <a:extLst>
              <a:ext uri="{FF2B5EF4-FFF2-40B4-BE49-F238E27FC236}">
                <a16:creationId xmlns:a16="http://schemas.microsoft.com/office/drawing/2014/main" id="{F0A27B93-B0FB-3DF3-9BB4-85FF29D8E878}"/>
              </a:ext>
            </a:extLst>
          </p:cNvPr>
          <p:cNvSpPr txBox="1"/>
          <p:nvPr/>
        </p:nvSpPr>
        <p:spPr>
          <a:xfrm>
            <a:off x="4620442" y="209550"/>
            <a:ext cx="293914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s-CL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" name="Google Shape;83;p8">
            <a:extLst>
              <a:ext uri="{FF2B5EF4-FFF2-40B4-BE49-F238E27FC236}">
                <a16:creationId xmlns:a16="http://schemas.microsoft.com/office/drawing/2014/main" id="{A2749C0F-9D76-2852-6DFE-B1CA43892591}"/>
              </a:ext>
            </a:extLst>
          </p:cNvPr>
          <p:cNvSpPr txBox="1"/>
          <p:nvPr/>
        </p:nvSpPr>
        <p:spPr>
          <a:xfrm>
            <a:off x="8761913" y="209509"/>
            <a:ext cx="293914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s-CL" sz="18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2" name="Objeto 1">
            <a:extLst>
              <a:ext uri="{FF2B5EF4-FFF2-40B4-BE49-F238E27FC236}">
                <a16:creationId xmlns:a16="http://schemas.microsoft.com/office/drawing/2014/main" id="{0F98F182-B591-321C-87E5-67BDCFA8B59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5597407"/>
              </p:ext>
            </p:extLst>
          </p:nvPr>
        </p:nvGraphicFramePr>
        <p:xfrm>
          <a:off x="4264796" y="354281"/>
          <a:ext cx="4565650" cy="2940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4" imgW="4566161" imgH="2939577" progId="Prism6.Document">
                  <p:embed/>
                </p:oleObj>
              </mc:Choice>
              <mc:Fallback>
                <p:oleObj name="Prism 6" r:id="rId4" imgW="4566161" imgH="2939577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264796" y="354281"/>
                        <a:ext cx="4565650" cy="2940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to 2">
            <a:extLst>
              <a:ext uri="{FF2B5EF4-FFF2-40B4-BE49-F238E27FC236}">
                <a16:creationId xmlns:a16="http://schemas.microsoft.com/office/drawing/2014/main" id="{F3DDE923-AF81-60B7-5FC8-5CE822DD229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56305512"/>
              </p:ext>
            </p:extLst>
          </p:nvPr>
        </p:nvGraphicFramePr>
        <p:xfrm>
          <a:off x="-13126" y="354281"/>
          <a:ext cx="4694237" cy="2940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6" imgW="4694009" imgH="2939577" progId="Prism6.Document">
                  <p:embed/>
                </p:oleObj>
              </mc:Choice>
              <mc:Fallback>
                <p:oleObj name="Prism 6" r:id="rId6" imgW="4694009" imgH="2939577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-13126" y="354281"/>
                        <a:ext cx="4694237" cy="2940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2442609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Google Shape;91;p9"/>
          <p:cNvSpPr txBox="1"/>
          <p:nvPr/>
        </p:nvSpPr>
        <p:spPr>
          <a:xfrm>
            <a:off x="-4804" y="1248697"/>
            <a:ext cx="100148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s-CL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750 bp</a:t>
            </a:r>
            <a:endParaRPr sz="18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92" name="Google Shape;92;p9"/>
          <p:cNvGrpSpPr/>
          <p:nvPr/>
        </p:nvGrpSpPr>
        <p:grpSpPr>
          <a:xfrm>
            <a:off x="-63500" y="2152879"/>
            <a:ext cx="9385300" cy="931137"/>
            <a:chOff x="-63500" y="3701868"/>
            <a:chExt cx="9385300" cy="931137"/>
          </a:xfrm>
        </p:grpSpPr>
        <p:sp>
          <p:nvSpPr>
            <p:cNvPr id="93" name="Google Shape;93;p9"/>
            <p:cNvSpPr txBox="1"/>
            <p:nvPr/>
          </p:nvSpPr>
          <p:spPr>
            <a:xfrm>
              <a:off x="-63500" y="4263673"/>
              <a:ext cx="1001486" cy="3693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s-CL" sz="1800" b="0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1000 bp</a:t>
              </a:r>
              <a:endPara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94" name="Google Shape;94;p9"/>
            <p:cNvSpPr txBox="1"/>
            <p:nvPr/>
          </p:nvSpPr>
          <p:spPr>
            <a:xfrm>
              <a:off x="1730827" y="3707430"/>
              <a:ext cx="1926771" cy="3693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s-CL" sz="1800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WT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95" name="Google Shape;95;p9"/>
            <p:cNvSpPr txBox="1"/>
            <p:nvPr/>
          </p:nvSpPr>
          <p:spPr>
            <a:xfrm>
              <a:off x="3875315" y="3707430"/>
              <a:ext cx="1926771" cy="3693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s-CL" sz="1800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L31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96" name="Google Shape;96;p9"/>
            <p:cNvSpPr txBox="1"/>
            <p:nvPr/>
          </p:nvSpPr>
          <p:spPr>
            <a:xfrm>
              <a:off x="6019803" y="3707430"/>
              <a:ext cx="1926771" cy="3693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s-CL" sz="1800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L4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97" name="Google Shape;97;p9"/>
            <p:cNvSpPr txBox="1"/>
            <p:nvPr/>
          </p:nvSpPr>
          <p:spPr>
            <a:xfrm>
              <a:off x="7395029" y="3701868"/>
              <a:ext cx="1926771" cy="3693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s-CL" sz="1800" b="1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-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cxnSp>
          <p:nvCxnSpPr>
            <p:cNvPr id="98" name="Google Shape;98;p9"/>
            <p:cNvCxnSpPr/>
            <p:nvPr/>
          </p:nvCxnSpPr>
          <p:spPr>
            <a:xfrm>
              <a:off x="1752599" y="4131582"/>
              <a:ext cx="1926771" cy="0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99" name="Google Shape;99;p9"/>
            <p:cNvCxnSpPr/>
            <p:nvPr/>
          </p:nvCxnSpPr>
          <p:spPr>
            <a:xfrm>
              <a:off x="3848100" y="4131582"/>
              <a:ext cx="1926000" cy="0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00" name="Google Shape;100;p9"/>
            <p:cNvCxnSpPr/>
            <p:nvPr/>
          </p:nvCxnSpPr>
          <p:spPr>
            <a:xfrm>
              <a:off x="5927271" y="4131582"/>
              <a:ext cx="1926000" cy="0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101" name="Google Shape;101;p9"/>
          <p:cNvSpPr txBox="1"/>
          <p:nvPr/>
        </p:nvSpPr>
        <p:spPr>
          <a:xfrm>
            <a:off x="1611084" y="389201"/>
            <a:ext cx="192677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s-CL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T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2" name="Google Shape;102;p9"/>
          <p:cNvSpPr txBox="1"/>
          <p:nvPr/>
        </p:nvSpPr>
        <p:spPr>
          <a:xfrm>
            <a:off x="3755572" y="389201"/>
            <a:ext cx="192677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s-CL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L31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3" name="Google Shape;103;p9"/>
          <p:cNvSpPr txBox="1"/>
          <p:nvPr/>
        </p:nvSpPr>
        <p:spPr>
          <a:xfrm>
            <a:off x="5900060" y="389201"/>
            <a:ext cx="192677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s-CL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L4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4" name="Google Shape;104;p9"/>
          <p:cNvSpPr txBox="1"/>
          <p:nvPr/>
        </p:nvSpPr>
        <p:spPr>
          <a:xfrm>
            <a:off x="7634515" y="389201"/>
            <a:ext cx="90895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s-CL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+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05" name="Google Shape;105;p9"/>
          <p:cNvCxnSpPr/>
          <p:nvPr/>
        </p:nvCxnSpPr>
        <p:spPr>
          <a:xfrm>
            <a:off x="1632856" y="813353"/>
            <a:ext cx="1926771" cy="0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106" name="Google Shape;106;p9"/>
          <p:cNvCxnSpPr/>
          <p:nvPr/>
        </p:nvCxnSpPr>
        <p:spPr>
          <a:xfrm>
            <a:off x="3728357" y="813353"/>
            <a:ext cx="1926000" cy="0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107" name="Google Shape;107;p9"/>
          <p:cNvCxnSpPr/>
          <p:nvPr/>
        </p:nvCxnSpPr>
        <p:spPr>
          <a:xfrm>
            <a:off x="5807528" y="813353"/>
            <a:ext cx="1926000" cy="0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108" name="Google Shape;108;p9"/>
          <p:cNvSpPr txBox="1"/>
          <p:nvPr/>
        </p:nvSpPr>
        <p:spPr>
          <a:xfrm>
            <a:off x="8344491" y="389201"/>
            <a:ext cx="90895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s-CL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-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9" name="Google Shape;109;p9"/>
          <p:cNvSpPr txBox="1"/>
          <p:nvPr/>
        </p:nvSpPr>
        <p:spPr>
          <a:xfrm>
            <a:off x="234043" y="4883339"/>
            <a:ext cx="11310300" cy="1477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s-CL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Figure 2. Expression analysis of </a:t>
            </a:r>
            <a:r>
              <a:rPr lang="es-CL" sz="1800" b="0" i="1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lLIP1-His </a:t>
            </a:r>
            <a:r>
              <a:rPr lang="es-CL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n leaves of WT and transgenic T2 plants. </a:t>
            </a:r>
            <a:r>
              <a:rPr lang="es-CL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A)</a:t>
            </a:r>
            <a:r>
              <a:rPr lang="es-CL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RT-PCR amplifying a fragment of 695 bp of introduced </a:t>
            </a:r>
            <a:r>
              <a:rPr lang="es-CL" sz="1800" b="0" i="1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lLIP1 </a:t>
            </a:r>
            <a:r>
              <a:rPr lang="es-CL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ranscripts, including the 6xHis tag. pCP-PG-SlLIP1 vector was used as a technical positive control (C+). </a:t>
            </a:r>
            <a:r>
              <a:rPr lang="es-CL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B)</a:t>
            </a:r>
            <a:r>
              <a:rPr lang="es-CL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RT-PCR amplifying a fragment of 785 bp of </a:t>
            </a:r>
            <a:r>
              <a:rPr lang="es-CL" sz="1800" b="0" i="1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APDH </a:t>
            </a:r>
            <a:r>
              <a:rPr lang="es-CL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ranscripts to confirm mRNA integrity. For each plant line, three biological replicates were analyzed. In the case of the negative controls (C-), water was used as a template.</a:t>
            </a:r>
            <a:endParaRPr sz="18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10" name="Google Shape;110;p9"/>
          <p:cNvSpPr txBox="1"/>
          <p:nvPr/>
        </p:nvSpPr>
        <p:spPr>
          <a:xfrm>
            <a:off x="92848" y="181115"/>
            <a:ext cx="100148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s-CL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11" name="Google Shape;111;p9"/>
          <p:cNvSpPr txBox="1"/>
          <p:nvPr/>
        </p:nvSpPr>
        <p:spPr>
          <a:xfrm>
            <a:off x="92848" y="2076196"/>
            <a:ext cx="100148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s-CL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112" name="Google Shape;112;p9"/>
          <p:cNvGraphicFramePr/>
          <p:nvPr/>
        </p:nvGraphicFramePr>
        <p:xfrm>
          <a:off x="933449" y="898234"/>
          <a:ext cx="8939895" cy="9676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" imgW="8939895" imgH="967664" progId="Photoshop.Image.13">
                  <p:embed/>
                </p:oleObj>
              </mc:Choice>
              <mc:Fallback>
                <p:oleObj r:id="rId3" imgW="8939895" imgH="967664" progId="Photoshop.Image.13">
                  <p:embed/>
                  <p:pic>
                    <p:nvPicPr>
                      <p:cNvPr id="112" name="Google Shape;112;p9"/>
                      <p:cNvPicPr preferRelativeResize="0"/>
                      <p:nvPr/>
                    </p:nvPicPr>
                    <p:blipFill rotWithShape="1">
                      <a:blip r:embed="rId4">
                        <a:alphaModFix/>
                      </a:blip>
                      <a:srcRect/>
                      <a:stretch/>
                    </p:blipFill>
                    <p:spPr>
                      <a:xfrm>
                        <a:off x="933449" y="898234"/>
                        <a:ext cx="8939895" cy="96766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13" name="Google Shape;113;p9"/>
          <p:cNvCxnSpPr/>
          <p:nvPr/>
        </p:nvCxnSpPr>
        <p:spPr>
          <a:xfrm>
            <a:off x="775928" y="1466182"/>
            <a:ext cx="174172" cy="0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graphicFrame>
        <p:nvGraphicFramePr>
          <p:cNvPr id="114" name="Google Shape;114;p9"/>
          <p:cNvGraphicFramePr/>
          <p:nvPr/>
        </p:nvGraphicFramePr>
        <p:xfrm>
          <a:off x="935588" y="2598894"/>
          <a:ext cx="8449712" cy="9920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5" imgW="8449712" imgH="992094" progId="Photoshop.Image.13">
                  <p:embed/>
                </p:oleObj>
              </mc:Choice>
              <mc:Fallback>
                <p:oleObj r:id="rId5" imgW="8449712" imgH="992094" progId="Photoshop.Image.13">
                  <p:embed/>
                  <p:pic>
                    <p:nvPicPr>
                      <p:cNvPr id="114" name="Google Shape;114;p9"/>
                      <p:cNvPicPr preferRelativeResize="0"/>
                      <p:nvPr/>
                    </p:nvPicPr>
                    <p:blipFill rotWithShape="1">
                      <a:blip r:embed="rId6">
                        <a:alphaModFix/>
                      </a:blip>
                      <a:srcRect/>
                      <a:stretch/>
                    </p:blipFill>
                    <p:spPr>
                      <a:xfrm>
                        <a:off x="935588" y="2598894"/>
                        <a:ext cx="8449712" cy="99209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15" name="Google Shape;115;p9"/>
          <p:cNvCxnSpPr/>
          <p:nvPr/>
        </p:nvCxnSpPr>
        <p:spPr>
          <a:xfrm>
            <a:off x="846363" y="2917732"/>
            <a:ext cx="174172" cy="0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Imagen que contiene Diagrama&#10;&#10;El contenido generado por IA puede ser incorrecto.">
            <a:extLst>
              <a:ext uri="{FF2B5EF4-FFF2-40B4-BE49-F238E27FC236}">
                <a16:creationId xmlns:a16="http://schemas.microsoft.com/office/drawing/2014/main" id="{167269C1-1765-5D4E-D286-CBBB56730BE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6441" y="822767"/>
            <a:ext cx="12172725" cy="3969929"/>
          </a:xfrm>
          <a:prstGeom prst="rect">
            <a:avLst/>
          </a:prstGeom>
        </p:spPr>
      </p:pic>
      <p:sp>
        <p:nvSpPr>
          <p:cNvPr id="122" name="Google Shape;122;p34"/>
          <p:cNvSpPr txBox="1"/>
          <p:nvPr/>
        </p:nvSpPr>
        <p:spPr>
          <a:xfrm>
            <a:off x="40273" y="609115"/>
            <a:ext cx="925253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es-CL" sz="1600" b="1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Anti-LA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3" name="Google Shape;123;p34"/>
          <p:cNvSpPr txBox="1"/>
          <p:nvPr/>
        </p:nvSpPr>
        <p:spPr>
          <a:xfrm>
            <a:off x="423883" y="1191794"/>
            <a:ext cx="503664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s-CL"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kDa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4" name="Google Shape;124;p34"/>
          <p:cNvSpPr txBox="1"/>
          <p:nvPr/>
        </p:nvSpPr>
        <p:spPr>
          <a:xfrm>
            <a:off x="5592336" y="1202488"/>
            <a:ext cx="503664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s-CL"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kDa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5" name="Google Shape;125;p34"/>
          <p:cNvSpPr txBox="1"/>
          <p:nvPr/>
        </p:nvSpPr>
        <p:spPr>
          <a:xfrm>
            <a:off x="-46459" y="3907099"/>
            <a:ext cx="1165704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es-CL" sz="1600" b="1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Anti-</a:t>
            </a:r>
            <a:r>
              <a:rPr lang="es-CL" sz="1600" b="1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Actin</a:t>
            </a:r>
            <a:endParaRPr sz="1600" b="1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6" name="Google Shape;126;p34"/>
          <p:cNvSpPr txBox="1"/>
          <p:nvPr/>
        </p:nvSpPr>
        <p:spPr>
          <a:xfrm>
            <a:off x="234043" y="4883339"/>
            <a:ext cx="11310300" cy="17542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Supplementary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Figure 3. Representative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immunoblots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of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lipoylated-proteins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(top) and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actin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(bottom) in WT and PG-SlLIP1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fruits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. Total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proteins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(25 μg)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were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separated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by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SDS-PAGE and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transferred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onto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nitrocellulose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membranes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.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The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antibodies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used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were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anti-LA (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against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lipoylated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proteins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) and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anti-actin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(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specific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for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Arabidopsis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actin-12) as a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loading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control.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Proteins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from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T0 and T2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fruits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are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displayed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in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the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left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and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right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panels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, </a:t>
            </a:r>
            <a:r>
              <a:rPr lang="es-CL" sz="1800" b="0" i="0" u="none" strike="noStrike" cap="none" dirty="0" err="1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respectively</a:t>
            </a:r>
            <a:r>
              <a:rPr lang="es-CL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. </a:t>
            </a:r>
            <a:r>
              <a:rPr lang="en-US" sz="1800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For quantification (Figure 2B), a</a:t>
            </a:r>
            <a:r>
              <a:rPr lang="en-US" sz="1800" b="0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ll T0 and T2 samples were subjected to this analysis at least three times, whilst 5 replicates were considered for WT.</a:t>
            </a:r>
            <a:endParaRPr sz="1800" b="0" i="0" u="none" strike="noStrike" cap="none" dirty="0">
              <a:solidFill>
                <a:schemeClr val="tx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27" name="Google Shape;127;p34"/>
          <p:cNvSpPr/>
          <p:nvPr/>
        </p:nvSpPr>
        <p:spPr>
          <a:xfrm>
            <a:off x="10803148" y="1987169"/>
            <a:ext cx="187885" cy="660400"/>
          </a:xfrm>
          <a:prstGeom prst="rightBrace">
            <a:avLst>
              <a:gd name="adj1" fmla="val 8333"/>
              <a:gd name="adj2" fmla="val 50000"/>
            </a:avLst>
          </a:prstGeom>
          <a:noFill/>
          <a:ln w="1905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28" name="Google Shape;128;p34"/>
          <p:cNvCxnSpPr/>
          <p:nvPr/>
        </p:nvCxnSpPr>
        <p:spPr>
          <a:xfrm>
            <a:off x="10789141" y="2831120"/>
            <a:ext cx="215900" cy="0"/>
          </a:xfrm>
          <a:prstGeom prst="straightConnector1">
            <a:avLst/>
          </a:prstGeom>
          <a:noFill/>
          <a:ln w="19050" cap="flat" cmpd="sng">
            <a:solidFill>
              <a:schemeClr val="dk1"/>
            </a:solidFill>
            <a:prstDash val="solid"/>
            <a:round/>
            <a:headEnd type="none" w="sm" len="sm"/>
            <a:tailEnd type="triangle" w="med" len="med"/>
          </a:ln>
        </p:spPr>
      </p:cxnSp>
      <p:sp>
        <p:nvSpPr>
          <p:cNvPr id="129" name="Google Shape;129;p34"/>
          <p:cNvSpPr txBox="1"/>
          <p:nvPr/>
        </p:nvSpPr>
        <p:spPr>
          <a:xfrm>
            <a:off x="10943388" y="2097449"/>
            <a:ext cx="925253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s-CL" sz="1800" b="0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E2 PDH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30" name="Google Shape;130;p34"/>
          <p:cNvSpPr txBox="1"/>
          <p:nvPr/>
        </p:nvSpPr>
        <p:spPr>
          <a:xfrm>
            <a:off x="10947890" y="2640620"/>
            <a:ext cx="1004374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s-CL" sz="1800" b="0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E2 kGDH</a:t>
            </a:r>
            <a:endParaRPr sz="1800" b="0" i="0" u="none" strike="noStrike" cap="none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1" name="Google Shape;131;p34"/>
          <p:cNvSpPr/>
          <p:nvPr/>
        </p:nvSpPr>
        <p:spPr>
          <a:xfrm>
            <a:off x="3125507" y="1890486"/>
            <a:ext cx="187885" cy="660400"/>
          </a:xfrm>
          <a:prstGeom prst="rightBrace">
            <a:avLst>
              <a:gd name="adj1" fmla="val 8333"/>
              <a:gd name="adj2" fmla="val 50000"/>
            </a:avLst>
          </a:prstGeom>
          <a:noFill/>
          <a:ln w="1905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32" name="Google Shape;132;p34"/>
          <p:cNvCxnSpPr/>
          <p:nvPr/>
        </p:nvCxnSpPr>
        <p:spPr>
          <a:xfrm>
            <a:off x="3111500" y="2813566"/>
            <a:ext cx="215900" cy="0"/>
          </a:xfrm>
          <a:prstGeom prst="straightConnector1">
            <a:avLst/>
          </a:prstGeom>
          <a:noFill/>
          <a:ln w="19050" cap="flat" cmpd="sng">
            <a:solidFill>
              <a:schemeClr val="dk1"/>
            </a:solidFill>
            <a:prstDash val="solid"/>
            <a:round/>
            <a:headEnd type="none" w="sm" len="sm"/>
            <a:tailEnd type="triangle" w="med" len="med"/>
          </a:ln>
        </p:spPr>
      </p:cxnSp>
      <p:sp>
        <p:nvSpPr>
          <p:cNvPr id="133" name="Google Shape;133;p34"/>
          <p:cNvSpPr txBox="1"/>
          <p:nvPr/>
        </p:nvSpPr>
        <p:spPr>
          <a:xfrm>
            <a:off x="3265747" y="2000766"/>
            <a:ext cx="925253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s-CL" sz="1800" b="0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E2 PDH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34" name="Google Shape;134;p34"/>
          <p:cNvSpPr txBox="1"/>
          <p:nvPr/>
        </p:nvSpPr>
        <p:spPr>
          <a:xfrm>
            <a:off x="3270249" y="2623066"/>
            <a:ext cx="1004374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s-CL" sz="1800" b="0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E2 kGDH</a:t>
            </a:r>
            <a:endParaRPr sz="1800" b="0" i="0" u="none" strike="noStrike" cap="none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9" name="Google Shape;139;p11"/>
          <p:cNvGraphicFramePr/>
          <p:nvPr/>
        </p:nvGraphicFramePr>
        <p:xfrm>
          <a:off x="2567577" y="1164773"/>
          <a:ext cx="7056846" cy="3352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" imgW="7056846" imgH="3352800" progId="Photoshop.Image.13">
                  <p:embed/>
                </p:oleObj>
              </mc:Choice>
              <mc:Fallback>
                <p:oleObj r:id="rId3" imgW="7056846" imgH="3352800" progId="Photoshop.Image.13">
                  <p:embed/>
                  <p:pic>
                    <p:nvPicPr>
                      <p:cNvPr id="139" name="Google Shape;139;p11"/>
                      <p:cNvPicPr preferRelativeResize="0"/>
                      <p:nvPr/>
                    </p:nvPicPr>
                    <p:blipFill rotWithShape="1">
                      <a:blip r:embed="rId4">
                        <a:alphaModFix/>
                      </a:blip>
                      <a:srcRect/>
                      <a:stretch/>
                    </p:blipFill>
                    <p:spPr>
                      <a:xfrm>
                        <a:off x="2567577" y="1164773"/>
                        <a:ext cx="7056846" cy="33528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40" name="Google Shape;140;p11"/>
          <p:cNvCxnSpPr/>
          <p:nvPr/>
        </p:nvCxnSpPr>
        <p:spPr>
          <a:xfrm>
            <a:off x="3407230" y="1164773"/>
            <a:ext cx="0" cy="3352800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141" name="Google Shape;141;p11"/>
          <p:cNvCxnSpPr/>
          <p:nvPr/>
        </p:nvCxnSpPr>
        <p:spPr>
          <a:xfrm>
            <a:off x="4198365" y="1164773"/>
            <a:ext cx="0" cy="3352800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142" name="Google Shape;142;p11"/>
          <p:cNvCxnSpPr/>
          <p:nvPr/>
        </p:nvCxnSpPr>
        <p:spPr>
          <a:xfrm>
            <a:off x="4964848" y="1164773"/>
            <a:ext cx="0" cy="3352800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143" name="Google Shape;143;p11"/>
          <p:cNvCxnSpPr/>
          <p:nvPr/>
        </p:nvCxnSpPr>
        <p:spPr>
          <a:xfrm>
            <a:off x="5758224" y="1164773"/>
            <a:ext cx="0" cy="3352800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144" name="Google Shape;144;p11"/>
          <p:cNvCxnSpPr/>
          <p:nvPr/>
        </p:nvCxnSpPr>
        <p:spPr>
          <a:xfrm>
            <a:off x="6578494" y="1164773"/>
            <a:ext cx="0" cy="3352800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145" name="Google Shape;145;p11"/>
          <p:cNvCxnSpPr/>
          <p:nvPr/>
        </p:nvCxnSpPr>
        <p:spPr>
          <a:xfrm>
            <a:off x="7385319" y="1164773"/>
            <a:ext cx="0" cy="3352800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146" name="Google Shape;146;p11"/>
          <p:cNvCxnSpPr/>
          <p:nvPr/>
        </p:nvCxnSpPr>
        <p:spPr>
          <a:xfrm>
            <a:off x="8098012" y="1164773"/>
            <a:ext cx="0" cy="3352800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147" name="Google Shape;147;p11"/>
          <p:cNvCxnSpPr/>
          <p:nvPr/>
        </p:nvCxnSpPr>
        <p:spPr>
          <a:xfrm>
            <a:off x="8884665" y="1164773"/>
            <a:ext cx="0" cy="3352800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148" name="Google Shape;148;p11"/>
          <p:cNvCxnSpPr/>
          <p:nvPr/>
        </p:nvCxnSpPr>
        <p:spPr>
          <a:xfrm rot="10800000">
            <a:off x="1055594" y="1960391"/>
            <a:ext cx="8568829" cy="0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149" name="Google Shape;149;p11"/>
          <p:cNvCxnSpPr/>
          <p:nvPr/>
        </p:nvCxnSpPr>
        <p:spPr>
          <a:xfrm rot="10800000">
            <a:off x="1055594" y="2841173"/>
            <a:ext cx="8568000" cy="0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150" name="Google Shape;150;p11"/>
          <p:cNvCxnSpPr/>
          <p:nvPr/>
        </p:nvCxnSpPr>
        <p:spPr>
          <a:xfrm rot="10800000">
            <a:off x="1055594" y="3598691"/>
            <a:ext cx="8568000" cy="0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151" name="Google Shape;151;p11"/>
          <p:cNvCxnSpPr/>
          <p:nvPr/>
        </p:nvCxnSpPr>
        <p:spPr>
          <a:xfrm>
            <a:off x="2567577" y="1164773"/>
            <a:ext cx="0" cy="3352800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152" name="Google Shape;152;p11"/>
          <p:cNvCxnSpPr/>
          <p:nvPr/>
        </p:nvCxnSpPr>
        <p:spPr>
          <a:xfrm rot="10800000">
            <a:off x="1055594" y="1164773"/>
            <a:ext cx="8568000" cy="0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153" name="Google Shape;153;p11"/>
          <p:cNvCxnSpPr/>
          <p:nvPr/>
        </p:nvCxnSpPr>
        <p:spPr>
          <a:xfrm>
            <a:off x="9624423" y="1164773"/>
            <a:ext cx="0" cy="3352800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154" name="Google Shape;154;p11"/>
          <p:cNvCxnSpPr/>
          <p:nvPr/>
        </p:nvCxnSpPr>
        <p:spPr>
          <a:xfrm rot="10800000">
            <a:off x="1055594" y="4517573"/>
            <a:ext cx="8568000" cy="0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155" name="Google Shape;155;p11"/>
          <p:cNvSpPr txBox="1"/>
          <p:nvPr/>
        </p:nvSpPr>
        <p:spPr>
          <a:xfrm>
            <a:off x="2034817" y="1383758"/>
            <a:ext cx="592481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000"/>
              <a:buFont typeface="Arial"/>
              <a:buNone/>
            </a:pPr>
            <a:r>
              <a:rPr lang="es-CL"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T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56" name="Google Shape;156;p11"/>
          <p:cNvSpPr txBox="1"/>
          <p:nvPr/>
        </p:nvSpPr>
        <p:spPr>
          <a:xfrm>
            <a:off x="973311" y="2210164"/>
            <a:ext cx="1653987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000"/>
              <a:buFont typeface="Arial"/>
              <a:buNone/>
            </a:pPr>
            <a:r>
              <a:rPr lang="es-CL"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G-SlLIP1 L31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57" name="Google Shape;157;p11"/>
          <p:cNvSpPr txBox="1"/>
          <p:nvPr/>
        </p:nvSpPr>
        <p:spPr>
          <a:xfrm>
            <a:off x="973311" y="3036570"/>
            <a:ext cx="1653987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000"/>
              <a:buFont typeface="Arial"/>
              <a:buNone/>
            </a:pPr>
            <a:r>
              <a:rPr lang="es-CL"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G-SlLIP1 L4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58" name="Google Shape;158;p11"/>
          <p:cNvSpPr txBox="1"/>
          <p:nvPr/>
        </p:nvSpPr>
        <p:spPr>
          <a:xfrm>
            <a:off x="2141608" y="3862977"/>
            <a:ext cx="485690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000"/>
              <a:buFont typeface="Arial"/>
              <a:buNone/>
            </a:pPr>
            <a:r>
              <a:rPr lang="es-CL"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+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59" name="Google Shape;159;p11"/>
          <p:cNvCxnSpPr/>
          <p:nvPr/>
        </p:nvCxnSpPr>
        <p:spPr>
          <a:xfrm>
            <a:off x="1072712" y="1164773"/>
            <a:ext cx="0" cy="3352800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160" name="Google Shape;160;p11"/>
          <p:cNvSpPr txBox="1"/>
          <p:nvPr/>
        </p:nvSpPr>
        <p:spPr>
          <a:xfrm>
            <a:off x="279441" y="5127792"/>
            <a:ext cx="11310300" cy="120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s-CL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Figure 4. Detection of unbound lipoic acid in WT and T2 PG-SlLIP1 fruits. Free lipoic acid extracted from mature red fruits was spotted onto a nitrocellulose membrane and incubated with anti-lipoic acid antibody. The positive control (C+) corresponds to lipoylated proteins extracted from T0 PG-SlLIP1 L4 fruits. Three biological replicates and three technical replicates were used.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28</TotalTime>
  <Words>616</Words>
  <Application>Microsoft Office PowerPoint</Application>
  <PresentationFormat>Widescreen</PresentationFormat>
  <Paragraphs>140</Paragraphs>
  <Slides>5</Slides>
  <Notes>4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Tema de Office</vt:lpstr>
      <vt:lpstr>Prism 6</vt:lpstr>
      <vt:lpstr>Photoshop.Image.13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marÃ­a paz covarrubias (maria.covarrubias)</dc:creator>
  <cp:lastModifiedBy>India Humphreys</cp:lastModifiedBy>
  <cp:revision>5</cp:revision>
  <dcterms:created xsi:type="dcterms:W3CDTF">2024-01-18T17:54:42Z</dcterms:created>
  <dcterms:modified xsi:type="dcterms:W3CDTF">2025-04-14T09:35:58Z</dcterms:modified>
</cp:coreProperties>
</file>